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59" r:id="rId3"/>
    <p:sldId id="257" r:id="rId4"/>
    <p:sldId id="260" r:id="rId5"/>
    <p:sldId id="267" r:id="rId6"/>
    <p:sldId id="268" r:id="rId7"/>
    <p:sldId id="258" r:id="rId8"/>
    <p:sldId id="266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1339" autoAdjust="0"/>
    <p:restoredTop sz="94660"/>
  </p:normalViewPr>
  <p:slideViewPr>
    <p:cSldViewPr snapToGrid="0">
      <p:cViewPr varScale="1">
        <p:scale>
          <a:sx n="85" d="100"/>
          <a:sy n="85" d="100"/>
        </p:scale>
        <p:origin x="96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D76480-E5DB-FA56-7E64-4AE9E32DC7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6B9A26-4223-B264-42C9-88749088FD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DA8E52-4BD0-BE50-4D1C-EBB44756CE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A973-DB67-46E3-8C9E-0353FEDF2882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1D4168-F0EA-1CA5-DE30-2A9140EEF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795AB6-43BB-FA0B-B5EC-AFBF744376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755C1-3888-469D-A4A4-B6A84FFC3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097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C78FC4-95DB-BAA3-D6DD-B4668B6CBA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A2D5B8-719A-ED79-641E-02F0B6B24B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BE5D95-7F71-3BC5-4816-99FC63DF7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A973-DB67-46E3-8C9E-0353FEDF2882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BF3831-7A15-E5E9-287E-298363E2B3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030DDB-3B04-A902-80AD-B3AAF8203C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755C1-3888-469D-A4A4-B6A84FFC3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113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B30A433-A32A-AA85-6843-9DCDE403C7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E585A-7AE7-1062-D767-7A335C2EB9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70E7C5-CF75-3C63-B276-DBC114E00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A973-DB67-46E3-8C9E-0353FEDF2882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60FA1B-2331-D900-D8F1-D0A412606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4BBA7D-053B-3519-4284-597B7BEFDD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755C1-3888-469D-A4A4-B6A84FFC3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8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0F4FC7-0C5E-90D9-0480-C43DC37546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5CC293-D241-F2E5-236A-16516EDDC3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3DDE1B-B6A0-0B4B-99FC-5311578534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A973-DB67-46E3-8C9E-0353FEDF2882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E5919E-2DF7-AE5C-52A5-7A55FD62CB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391352-D612-60E3-6D4B-864EF61EE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755C1-3888-469D-A4A4-B6A84FFC3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3909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1F4451-E17D-EBDD-A4A0-7C4F051CD4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3FBC51-DDD5-D6AA-F357-FCBBD31EA4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13EA08-BBDF-639E-D2E7-5B5A3BAFC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A973-DB67-46E3-8C9E-0353FEDF2882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804C4F-B668-A9E1-947F-8504B0E675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7659C1-0DFD-D1A3-2D25-90BA90175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755C1-3888-469D-A4A4-B6A84FFC3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0325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4C5EC2-3FC5-F100-23CB-938961A9F2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5AAE9D-FF92-1C7A-86EA-9D5C269CC9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1161A4-CC7E-B636-8569-1EB5679634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FF1E45-2A43-5D4E-E3E6-95E1096085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A973-DB67-46E3-8C9E-0353FEDF2882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70DDC1-C258-1221-C69F-927C7193E2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F3D32F-8CED-F4EA-B6BD-2FD20219D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755C1-3888-469D-A4A4-B6A84FFC3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951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6CB09-CA24-6525-8CB8-559FB250C5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DCCCEC-6AF2-5D8A-ED6D-AEC47A3BAA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408035-3837-DBC6-428D-EB752D25CA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607505-9415-5B18-0D92-5C061D7140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0240E3-801B-5795-E2DA-69B9D685E4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79BEC3-6F39-340B-2DA1-F97CDB523A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A973-DB67-46E3-8C9E-0353FEDF2882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C1E8677-0E7F-F256-062C-21E200E18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0EDC484-DC0B-D5E9-6725-89270545D9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755C1-3888-469D-A4A4-B6A84FFC3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060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CFA991-286A-F614-D9EC-A2D06EAE7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952893-ED0B-E42F-8FCF-49A1ADAA8E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A973-DB67-46E3-8C9E-0353FEDF2882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43926DA-A1DF-E43C-C8B1-F323D0E02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0AA8C7-AD18-12DF-CC4A-5A324CE50D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755C1-3888-469D-A4A4-B6A84FFC3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9273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6B043FF-45A3-92FF-EABC-B6DA7B9BA2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A973-DB67-46E3-8C9E-0353FEDF2882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8B2FCD2-53DD-67B6-6AC9-012D6386A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427949C-C418-8EE6-5EFD-BEA88EC454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755C1-3888-469D-A4A4-B6A84FFC3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896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3F0ADE-BE4A-3696-6088-E32DF67842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9AC473-4443-08BD-9FA0-EE2BC08360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B227BD-5D17-B970-0271-44F9D7DD5A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B0E4A8-6E17-3382-E193-D45D904A9E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A973-DB67-46E3-8C9E-0353FEDF2882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D02326-4101-4CD0-DFC8-8566566DF0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C4B19B-D532-165C-7B81-35755A940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755C1-3888-469D-A4A4-B6A84FFC3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383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CD4669-4C01-F9D5-A7D3-EDD8AB2624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E18589-3A6C-2449-DBF1-627F1116E94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493A6B-7B21-2A85-0109-7FBC52CE80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586611-1EBA-D831-F527-556742446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A973-DB67-46E3-8C9E-0353FEDF2882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2227BD-894C-E6C7-0F10-A1AD5AAD7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F34958-5527-E573-092B-8B0E35658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755C1-3888-469D-A4A4-B6A84FFC3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2270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CA53312-1197-3B87-27B2-7F8EE9D1B5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0B7BB9-3782-D2EB-DBAA-6FF6F084DD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01A4B7-83E2-74BE-E72D-5292A37F48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FA973-DB67-46E3-8C9E-0353FEDF2882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5FDC42-26AA-1614-A3E8-692B19B37A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345848-DD9B-82E0-18F3-3ECB8F01A6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1755C1-3888-469D-A4A4-B6A84FFC3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757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jpe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tiff"/><Relationship Id="rId4" Type="http://schemas.openxmlformats.org/officeDocument/2006/relationships/image" Target="../media/image16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g"/><Relationship Id="rId3" Type="http://schemas.microsoft.com/office/2007/relationships/hdphoto" Target="../media/hdphoto3.wdp"/><Relationship Id="rId7" Type="http://schemas.microsoft.com/office/2007/relationships/hdphoto" Target="../media/hdphoto5.wdp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png"/><Relationship Id="rId5" Type="http://schemas.microsoft.com/office/2007/relationships/hdphoto" Target="../media/hdphoto4.wdp"/><Relationship Id="rId10" Type="http://schemas.microsoft.com/office/2007/relationships/hdphoto" Target="../media/hdphoto6.wdp"/><Relationship Id="rId4" Type="http://schemas.openxmlformats.org/officeDocument/2006/relationships/image" Target="../media/image19.png"/><Relationship Id="rId9" Type="http://schemas.openxmlformats.org/officeDocument/2006/relationships/image" Target="../media/image2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AC8BD95-F484-5399-32A9-F55840E42BAB}"/>
              </a:ext>
            </a:extLst>
          </p:cNvPr>
          <p:cNvSpPr txBox="1"/>
          <p:nvPr/>
        </p:nvSpPr>
        <p:spPr>
          <a:xfrm>
            <a:off x="902442" y="1118357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1k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6" t="14720" r="8822" b="55799"/>
          <a:stretch/>
        </p:blipFill>
        <p:spPr>
          <a:xfrm>
            <a:off x="3262166" y="2286574"/>
            <a:ext cx="5391640" cy="1348033"/>
          </a:xfrm>
          <a:prstGeom prst="rect">
            <a:avLst/>
          </a:prstGeom>
          <a:ln w="25400">
            <a:noFill/>
          </a:ln>
        </p:spPr>
      </p:pic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90" t="18430" r="6824" b="51834"/>
          <a:stretch/>
        </p:blipFill>
        <p:spPr>
          <a:xfrm>
            <a:off x="3280528" y="3662887"/>
            <a:ext cx="5505253" cy="1310326"/>
          </a:xfrm>
          <a:prstGeom prst="rect">
            <a:avLst/>
          </a:prstGeom>
          <a:ln w="25400">
            <a:noFill/>
          </a:ln>
        </p:spPr>
      </p:pic>
      <p:sp>
        <p:nvSpPr>
          <p:cNvPr id="33" name="TextBox 32"/>
          <p:cNvSpPr txBox="1"/>
          <p:nvPr/>
        </p:nvSpPr>
        <p:spPr>
          <a:xfrm>
            <a:off x="2658848" y="2405554"/>
            <a:ext cx="1046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72 </a:t>
            </a:r>
            <a:endParaRPr lang="en-US" sz="1400" dirty="0"/>
          </a:p>
        </p:txBody>
      </p:sp>
      <p:sp>
        <p:nvSpPr>
          <p:cNvPr id="34" name="TextBox 33"/>
          <p:cNvSpPr txBox="1"/>
          <p:nvPr/>
        </p:nvSpPr>
        <p:spPr>
          <a:xfrm>
            <a:off x="2668273" y="2217017"/>
            <a:ext cx="1046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95</a:t>
            </a:r>
            <a:endParaRPr lang="en-US" sz="1400" dirty="0"/>
          </a:p>
        </p:txBody>
      </p:sp>
      <p:sp>
        <p:nvSpPr>
          <p:cNvPr id="35" name="TextBox 34"/>
          <p:cNvSpPr txBox="1"/>
          <p:nvPr/>
        </p:nvSpPr>
        <p:spPr>
          <a:xfrm>
            <a:off x="2649426" y="2594091"/>
            <a:ext cx="1046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55 </a:t>
            </a:r>
            <a:endParaRPr lang="en-US" sz="1400" dirty="0"/>
          </a:p>
        </p:txBody>
      </p:sp>
      <p:sp>
        <p:nvSpPr>
          <p:cNvPr id="36" name="TextBox 35"/>
          <p:cNvSpPr txBox="1"/>
          <p:nvPr/>
        </p:nvSpPr>
        <p:spPr>
          <a:xfrm>
            <a:off x="2641567" y="2803053"/>
            <a:ext cx="1046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43</a:t>
            </a:r>
            <a:endParaRPr lang="en-US" sz="1400" dirty="0"/>
          </a:p>
        </p:txBody>
      </p:sp>
      <p:sp>
        <p:nvSpPr>
          <p:cNvPr id="37" name="TextBox 36"/>
          <p:cNvSpPr txBox="1"/>
          <p:nvPr/>
        </p:nvSpPr>
        <p:spPr>
          <a:xfrm>
            <a:off x="2639997" y="3088921"/>
            <a:ext cx="1046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34</a:t>
            </a:r>
            <a:endParaRPr lang="en-US" sz="1400" dirty="0"/>
          </a:p>
        </p:txBody>
      </p:sp>
      <p:sp>
        <p:nvSpPr>
          <p:cNvPr id="38" name="TextBox 37"/>
          <p:cNvSpPr txBox="1"/>
          <p:nvPr/>
        </p:nvSpPr>
        <p:spPr>
          <a:xfrm>
            <a:off x="9135064" y="2713331"/>
            <a:ext cx="1574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phospho</a:t>
            </a:r>
            <a:r>
              <a:rPr lang="en-US" b="1" dirty="0" smtClean="0"/>
              <a:t> </a:t>
            </a:r>
            <a:r>
              <a:rPr lang="en-US" b="1" dirty="0" err="1" smtClean="0"/>
              <a:t>Akt</a:t>
            </a:r>
            <a:endParaRPr lang="en-US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9135064" y="3934075"/>
            <a:ext cx="1574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total </a:t>
            </a:r>
            <a:r>
              <a:rPr lang="en-US" b="1" dirty="0" err="1" smtClean="0"/>
              <a:t>Akt</a:t>
            </a:r>
            <a:endParaRPr lang="en-US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9278037" y="5316087"/>
            <a:ext cx="1574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GAPDH</a:t>
            </a:r>
            <a:endParaRPr lang="en-US" b="1" dirty="0"/>
          </a:p>
        </p:txBody>
      </p:sp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0" t="49498" r="4424" b="33093"/>
          <a:stretch/>
        </p:blipFill>
        <p:spPr>
          <a:xfrm>
            <a:off x="3054285" y="5114614"/>
            <a:ext cx="5694281" cy="782425"/>
          </a:xfrm>
          <a:prstGeom prst="rect">
            <a:avLst/>
          </a:prstGeom>
          <a:ln w="25400">
            <a:noFill/>
          </a:ln>
        </p:spPr>
      </p:pic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8217ABCF-E6D8-2E53-F346-A8963E9D4EED}"/>
              </a:ext>
            </a:extLst>
          </p:cNvPr>
          <p:cNvCxnSpPr/>
          <p:nvPr/>
        </p:nvCxnSpPr>
        <p:spPr>
          <a:xfrm>
            <a:off x="2990655" y="2399886"/>
            <a:ext cx="274449" cy="12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8217ABCF-E6D8-2E53-F346-A8963E9D4EED}"/>
              </a:ext>
            </a:extLst>
          </p:cNvPr>
          <p:cNvCxnSpPr/>
          <p:nvPr/>
        </p:nvCxnSpPr>
        <p:spPr>
          <a:xfrm>
            <a:off x="2992222" y="2561713"/>
            <a:ext cx="274449" cy="12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8217ABCF-E6D8-2E53-F346-A8963E9D4EED}"/>
              </a:ext>
            </a:extLst>
          </p:cNvPr>
          <p:cNvCxnSpPr/>
          <p:nvPr/>
        </p:nvCxnSpPr>
        <p:spPr>
          <a:xfrm>
            <a:off x="2984363" y="2742394"/>
            <a:ext cx="274449" cy="12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8217ABCF-E6D8-2E53-F346-A8963E9D4EED}"/>
              </a:ext>
            </a:extLst>
          </p:cNvPr>
          <p:cNvCxnSpPr/>
          <p:nvPr/>
        </p:nvCxnSpPr>
        <p:spPr>
          <a:xfrm>
            <a:off x="2986679" y="2971532"/>
            <a:ext cx="274449" cy="12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8217ABCF-E6D8-2E53-F346-A8963E9D4EED}"/>
              </a:ext>
            </a:extLst>
          </p:cNvPr>
          <p:cNvCxnSpPr/>
          <p:nvPr/>
        </p:nvCxnSpPr>
        <p:spPr>
          <a:xfrm>
            <a:off x="2992131" y="3249190"/>
            <a:ext cx="274449" cy="12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2773542" y="3755162"/>
            <a:ext cx="1046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72 </a:t>
            </a:r>
            <a:endParaRPr lang="en-US" sz="1400" dirty="0"/>
          </a:p>
        </p:txBody>
      </p:sp>
      <p:sp>
        <p:nvSpPr>
          <p:cNvPr id="48" name="TextBox 47"/>
          <p:cNvSpPr txBox="1"/>
          <p:nvPr/>
        </p:nvSpPr>
        <p:spPr>
          <a:xfrm>
            <a:off x="2782967" y="3566625"/>
            <a:ext cx="1046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95</a:t>
            </a:r>
            <a:endParaRPr lang="en-US" sz="1400" dirty="0"/>
          </a:p>
        </p:txBody>
      </p:sp>
      <p:sp>
        <p:nvSpPr>
          <p:cNvPr id="49" name="TextBox 48"/>
          <p:cNvSpPr txBox="1"/>
          <p:nvPr/>
        </p:nvSpPr>
        <p:spPr>
          <a:xfrm>
            <a:off x="2764120" y="3943699"/>
            <a:ext cx="1046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55 </a:t>
            </a:r>
            <a:endParaRPr lang="en-US" sz="1400" dirty="0"/>
          </a:p>
        </p:txBody>
      </p:sp>
      <p:sp>
        <p:nvSpPr>
          <p:cNvPr id="50" name="TextBox 49"/>
          <p:cNvSpPr txBox="1"/>
          <p:nvPr/>
        </p:nvSpPr>
        <p:spPr>
          <a:xfrm>
            <a:off x="2756261" y="4152661"/>
            <a:ext cx="1046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43</a:t>
            </a:r>
            <a:endParaRPr lang="en-US" sz="1400" dirty="0"/>
          </a:p>
        </p:txBody>
      </p:sp>
      <p:sp>
        <p:nvSpPr>
          <p:cNvPr id="51" name="TextBox 50"/>
          <p:cNvSpPr txBox="1"/>
          <p:nvPr/>
        </p:nvSpPr>
        <p:spPr>
          <a:xfrm>
            <a:off x="2754691" y="4438529"/>
            <a:ext cx="1046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34</a:t>
            </a:r>
            <a:endParaRPr lang="en-US" sz="1400" dirty="0"/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8217ABCF-E6D8-2E53-F346-A8963E9D4EED}"/>
              </a:ext>
            </a:extLst>
          </p:cNvPr>
          <p:cNvCxnSpPr/>
          <p:nvPr/>
        </p:nvCxnSpPr>
        <p:spPr>
          <a:xfrm>
            <a:off x="3095922" y="3749494"/>
            <a:ext cx="274449" cy="12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8217ABCF-E6D8-2E53-F346-A8963E9D4EED}"/>
              </a:ext>
            </a:extLst>
          </p:cNvPr>
          <p:cNvCxnSpPr/>
          <p:nvPr/>
        </p:nvCxnSpPr>
        <p:spPr>
          <a:xfrm>
            <a:off x="3088062" y="3911321"/>
            <a:ext cx="274449" cy="12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8217ABCF-E6D8-2E53-F346-A8963E9D4EED}"/>
              </a:ext>
            </a:extLst>
          </p:cNvPr>
          <p:cNvCxnSpPr/>
          <p:nvPr/>
        </p:nvCxnSpPr>
        <p:spPr>
          <a:xfrm>
            <a:off x="3089630" y="4092002"/>
            <a:ext cx="274449" cy="12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8217ABCF-E6D8-2E53-F346-A8963E9D4EED}"/>
              </a:ext>
            </a:extLst>
          </p:cNvPr>
          <p:cNvCxnSpPr/>
          <p:nvPr/>
        </p:nvCxnSpPr>
        <p:spPr>
          <a:xfrm>
            <a:off x="3073092" y="4321140"/>
            <a:ext cx="274449" cy="12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8217ABCF-E6D8-2E53-F346-A8963E9D4EED}"/>
              </a:ext>
            </a:extLst>
          </p:cNvPr>
          <p:cNvCxnSpPr/>
          <p:nvPr/>
        </p:nvCxnSpPr>
        <p:spPr>
          <a:xfrm>
            <a:off x="3069117" y="4598798"/>
            <a:ext cx="274449" cy="12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2746837" y="5114195"/>
            <a:ext cx="1046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55 </a:t>
            </a:r>
            <a:endParaRPr lang="en-US" sz="1400" dirty="0"/>
          </a:p>
        </p:txBody>
      </p:sp>
      <p:sp>
        <p:nvSpPr>
          <p:cNvPr id="58" name="TextBox 57"/>
          <p:cNvSpPr txBox="1"/>
          <p:nvPr/>
        </p:nvSpPr>
        <p:spPr>
          <a:xfrm>
            <a:off x="2738978" y="5323157"/>
            <a:ext cx="1046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43</a:t>
            </a:r>
            <a:endParaRPr lang="en-US" sz="1400" dirty="0"/>
          </a:p>
        </p:txBody>
      </p:sp>
      <p:sp>
        <p:nvSpPr>
          <p:cNvPr id="59" name="TextBox 58"/>
          <p:cNvSpPr txBox="1"/>
          <p:nvPr/>
        </p:nvSpPr>
        <p:spPr>
          <a:xfrm>
            <a:off x="2737408" y="5609025"/>
            <a:ext cx="1046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34</a:t>
            </a:r>
            <a:endParaRPr lang="en-US" sz="1400" dirty="0"/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8217ABCF-E6D8-2E53-F346-A8963E9D4EED}"/>
              </a:ext>
            </a:extLst>
          </p:cNvPr>
          <p:cNvCxnSpPr/>
          <p:nvPr/>
        </p:nvCxnSpPr>
        <p:spPr>
          <a:xfrm>
            <a:off x="3072347" y="5262498"/>
            <a:ext cx="274449" cy="12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8217ABCF-E6D8-2E53-F346-A8963E9D4EED}"/>
              </a:ext>
            </a:extLst>
          </p:cNvPr>
          <p:cNvCxnSpPr/>
          <p:nvPr/>
        </p:nvCxnSpPr>
        <p:spPr>
          <a:xfrm>
            <a:off x="3055809" y="5491636"/>
            <a:ext cx="274449" cy="12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8217ABCF-E6D8-2E53-F346-A8963E9D4EED}"/>
              </a:ext>
            </a:extLst>
          </p:cNvPr>
          <p:cNvCxnSpPr/>
          <p:nvPr/>
        </p:nvCxnSpPr>
        <p:spPr>
          <a:xfrm>
            <a:off x="3051834" y="5769294"/>
            <a:ext cx="274449" cy="12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3" name="Rectangle 62"/>
          <p:cNvSpPr/>
          <p:nvPr/>
        </p:nvSpPr>
        <p:spPr>
          <a:xfrm>
            <a:off x="3944521" y="2412172"/>
            <a:ext cx="3653483" cy="611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/>
          <p:cNvSpPr/>
          <p:nvPr/>
        </p:nvSpPr>
        <p:spPr>
          <a:xfrm>
            <a:off x="3886778" y="3776008"/>
            <a:ext cx="3653483" cy="611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Rectangle 64"/>
          <p:cNvSpPr/>
          <p:nvPr/>
        </p:nvSpPr>
        <p:spPr>
          <a:xfrm>
            <a:off x="3944520" y="5262497"/>
            <a:ext cx="3653483" cy="5439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5813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E33EBE2-86F9-B0BE-029C-FDBB3C4347D8}"/>
              </a:ext>
            </a:extLst>
          </p:cNvPr>
          <p:cNvSpPr txBox="1"/>
          <p:nvPr/>
        </p:nvSpPr>
        <p:spPr>
          <a:xfrm>
            <a:off x="555171" y="599497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2n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69982423-B3D1-186D-13E0-941B23FF9F78}"/>
              </a:ext>
            </a:extLst>
          </p:cNvPr>
          <p:cNvGrpSpPr/>
          <p:nvPr/>
        </p:nvGrpSpPr>
        <p:grpSpPr>
          <a:xfrm>
            <a:off x="1171113" y="1725093"/>
            <a:ext cx="4075801" cy="3058513"/>
            <a:chOff x="4447421" y="5080441"/>
            <a:chExt cx="2163221" cy="1675680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5AC76B41-1872-F6A7-9595-B6E9AD900B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-7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04" t="1440" r="8056" b="7782"/>
            <a:stretch/>
          </p:blipFill>
          <p:spPr>
            <a:xfrm>
              <a:off x="4791099" y="5338858"/>
              <a:ext cx="1819543" cy="1417263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3B6C29C-96E5-CB2F-757F-D05BC10632DA}"/>
                </a:ext>
              </a:extLst>
            </p:cNvPr>
            <p:cNvSpPr txBox="1"/>
            <p:nvPr/>
          </p:nvSpPr>
          <p:spPr>
            <a:xfrm>
              <a:off x="5543542" y="5080441"/>
              <a:ext cx="399858" cy="185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43A0E9D5-0D87-DABF-38C4-90EE6397E55A}"/>
                </a:ext>
              </a:extLst>
            </p:cNvPr>
            <p:cNvCxnSpPr/>
            <p:nvPr/>
          </p:nvCxnSpPr>
          <p:spPr>
            <a:xfrm>
              <a:off x="4738824" y="6120681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F9E6DCF-762D-4B03-0FEC-60BAE770CC1A}"/>
                </a:ext>
              </a:extLst>
            </p:cNvPr>
            <p:cNvSpPr txBox="1"/>
            <p:nvPr/>
          </p:nvSpPr>
          <p:spPr>
            <a:xfrm>
              <a:off x="4447421" y="5966792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0</a:t>
              </a: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9FB36EC1-AF1A-114D-6BDA-3B8BBE263AB5}"/>
                </a:ext>
              </a:extLst>
            </p:cNvPr>
            <p:cNvCxnSpPr/>
            <p:nvPr/>
          </p:nvCxnSpPr>
          <p:spPr>
            <a:xfrm>
              <a:off x="4739754" y="5950345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F5D7932-DA2C-793E-E71F-65ED167C208E}"/>
                </a:ext>
              </a:extLst>
            </p:cNvPr>
            <p:cNvSpPr txBox="1"/>
            <p:nvPr/>
          </p:nvSpPr>
          <p:spPr>
            <a:xfrm>
              <a:off x="4447421" y="579751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75</a:t>
              </a:r>
            </a:p>
          </p:txBody>
        </p:sp>
      </p:grpSp>
      <p:pic>
        <p:nvPicPr>
          <p:cNvPr id="9" name="Picture 8">
            <a:extLst>
              <a:ext uri="{FF2B5EF4-FFF2-40B4-BE49-F238E27FC236}">
                <a16:creationId xmlns:a16="http://schemas.microsoft.com/office/drawing/2014/main" id="{93C41A2F-5D09-E334-FDD1-798EDA2DAF1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05" r="17101"/>
          <a:stretch/>
        </p:blipFill>
        <p:spPr>
          <a:xfrm>
            <a:off x="7635224" y="2063647"/>
            <a:ext cx="3103574" cy="2594519"/>
          </a:xfrm>
          <a:prstGeom prst="rect">
            <a:avLst/>
          </a:prstGeom>
          <a:ln w="3175">
            <a:noFill/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A014A08-5AB3-67B0-2013-D6F490078853}"/>
              </a:ext>
            </a:extLst>
          </p:cNvPr>
          <p:cNvSpPr txBox="1"/>
          <p:nvPr/>
        </p:nvSpPr>
        <p:spPr>
          <a:xfrm>
            <a:off x="8659177" y="1725093"/>
            <a:ext cx="1055669" cy="3385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635846EB-2530-2919-F63B-23A18E616991}"/>
              </a:ext>
            </a:extLst>
          </p:cNvPr>
          <p:cNvCxnSpPr/>
          <p:nvPr/>
        </p:nvCxnSpPr>
        <p:spPr>
          <a:xfrm>
            <a:off x="7231013" y="3157131"/>
            <a:ext cx="622200" cy="158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03053093-4F2A-46CF-62FA-7222D4278ABF}"/>
              </a:ext>
            </a:extLst>
          </p:cNvPr>
          <p:cNvSpPr txBox="1"/>
          <p:nvPr/>
        </p:nvSpPr>
        <p:spPr>
          <a:xfrm>
            <a:off x="6491544" y="2927077"/>
            <a:ext cx="930007" cy="4601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6EB84395-6EB6-FD06-B336-ACFB758DD518}"/>
              </a:ext>
            </a:extLst>
          </p:cNvPr>
          <p:cNvCxnSpPr/>
          <p:nvPr/>
        </p:nvCxnSpPr>
        <p:spPr>
          <a:xfrm>
            <a:off x="7231013" y="3488980"/>
            <a:ext cx="622200" cy="158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43B92C26-2593-F345-3885-8D6F534153F8}"/>
              </a:ext>
            </a:extLst>
          </p:cNvPr>
          <p:cNvSpPr txBox="1"/>
          <p:nvPr/>
        </p:nvSpPr>
        <p:spPr>
          <a:xfrm>
            <a:off x="6491544" y="3258926"/>
            <a:ext cx="930007" cy="4601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1C8150C5-631A-F625-4A72-8195AE4E557F}"/>
              </a:ext>
            </a:extLst>
          </p:cNvPr>
          <p:cNvSpPr/>
          <p:nvPr/>
        </p:nvSpPr>
        <p:spPr>
          <a:xfrm>
            <a:off x="2252724" y="3258926"/>
            <a:ext cx="3090931" cy="2847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1F620278-532F-6D45-8292-8BE6DA3995B8}"/>
              </a:ext>
            </a:extLst>
          </p:cNvPr>
          <p:cNvSpPr/>
          <p:nvPr/>
        </p:nvSpPr>
        <p:spPr>
          <a:xfrm>
            <a:off x="7976105" y="3170495"/>
            <a:ext cx="3090931" cy="2847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3687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14E3930-6ED2-6A0A-5C02-7A1336FF64C2}"/>
              </a:ext>
            </a:extLst>
          </p:cNvPr>
          <p:cNvSpPr txBox="1"/>
          <p:nvPr/>
        </p:nvSpPr>
        <p:spPr>
          <a:xfrm>
            <a:off x="280659" y="734828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4a 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39D96385-E4A5-B1B2-9C9D-5CA3A26D083F}"/>
              </a:ext>
            </a:extLst>
          </p:cNvPr>
          <p:cNvGrpSpPr/>
          <p:nvPr/>
        </p:nvGrpSpPr>
        <p:grpSpPr>
          <a:xfrm>
            <a:off x="5233643" y="2222544"/>
            <a:ext cx="4330605" cy="2805429"/>
            <a:chOff x="4333545" y="4490429"/>
            <a:chExt cx="2828091" cy="1831086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DEED2852-BAA6-E71E-C6B1-AF4300BF1A9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06472" y="4490429"/>
              <a:ext cx="2455164" cy="1831086"/>
            </a:xfrm>
            <a:prstGeom prst="rect">
              <a:avLst/>
            </a:prstGeom>
          </p:spPr>
        </p:pic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815D37B5-AF41-5662-3206-E7CA8CBCE910}"/>
                </a:ext>
              </a:extLst>
            </p:cNvPr>
            <p:cNvCxnSpPr/>
            <p:nvPr/>
          </p:nvCxnSpPr>
          <p:spPr>
            <a:xfrm>
              <a:off x="4625679" y="5156453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596EA5F-B86D-671C-4D52-69E6632A7C5C}"/>
                </a:ext>
              </a:extLst>
            </p:cNvPr>
            <p:cNvSpPr txBox="1"/>
            <p:nvPr/>
          </p:nvSpPr>
          <p:spPr>
            <a:xfrm>
              <a:off x="4333545" y="5002564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0</a:t>
              </a:r>
            </a:p>
          </p:txBody>
        </p: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F729B5DD-4955-EBDE-10CB-B2311C6CEF63}"/>
                </a:ext>
              </a:extLst>
            </p:cNvPr>
            <p:cNvCxnSpPr/>
            <p:nvPr/>
          </p:nvCxnSpPr>
          <p:spPr>
            <a:xfrm>
              <a:off x="4625679" y="5449503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33E2B88-2119-965F-B9B4-DC3B4CE446DC}"/>
                </a:ext>
              </a:extLst>
            </p:cNvPr>
            <p:cNvSpPr txBox="1"/>
            <p:nvPr/>
          </p:nvSpPr>
          <p:spPr>
            <a:xfrm>
              <a:off x="4333545" y="5295614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37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405C98F7-3D46-CBF6-9FB8-7EC8FFBDD1BA}"/>
              </a:ext>
            </a:extLst>
          </p:cNvPr>
          <p:cNvSpPr txBox="1"/>
          <p:nvPr/>
        </p:nvSpPr>
        <p:spPr>
          <a:xfrm>
            <a:off x="7325240" y="1972484"/>
            <a:ext cx="7184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NX5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422836F-29F9-0799-478B-5B1F8574A83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550" y="2404830"/>
            <a:ext cx="3454222" cy="2623143"/>
          </a:xfrm>
          <a:prstGeom prst="rect">
            <a:avLst/>
          </a:prstGeom>
        </p:spPr>
      </p:pic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8217ABCF-E6D8-2E53-F346-A8963E9D4EED}"/>
              </a:ext>
            </a:extLst>
          </p:cNvPr>
          <p:cNvCxnSpPr/>
          <p:nvPr/>
        </p:nvCxnSpPr>
        <p:spPr>
          <a:xfrm>
            <a:off x="1586589" y="3375247"/>
            <a:ext cx="274449" cy="12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317719BD-FC51-B5BA-7940-C565C3522FD5}"/>
              </a:ext>
            </a:extLst>
          </p:cNvPr>
          <p:cNvSpPr txBox="1"/>
          <p:nvPr/>
        </p:nvSpPr>
        <p:spPr>
          <a:xfrm>
            <a:off x="1260414" y="3200295"/>
            <a:ext cx="410221" cy="3499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5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3A21C606-C5B8-6226-945F-0D8ABF182603}"/>
              </a:ext>
            </a:extLst>
          </p:cNvPr>
          <p:cNvCxnSpPr/>
          <p:nvPr/>
        </p:nvCxnSpPr>
        <p:spPr>
          <a:xfrm>
            <a:off x="1586589" y="3708407"/>
            <a:ext cx="274449" cy="12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A449063E-AC8D-D732-C7D2-13836C7D8989}"/>
              </a:ext>
            </a:extLst>
          </p:cNvPr>
          <p:cNvSpPr txBox="1"/>
          <p:nvPr/>
        </p:nvSpPr>
        <p:spPr>
          <a:xfrm>
            <a:off x="1260414" y="3533455"/>
            <a:ext cx="410221" cy="3499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7860B4B5-52B4-62C0-AFF7-502ABE810BF1}"/>
              </a:ext>
            </a:extLst>
          </p:cNvPr>
          <p:cNvSpPr/>
          <p:nvPr/>
        </p:nvSpPr>
        <p:spPr>
          <a:xfrm>
            <a:off x="1925607" y="3283948"/>
            <a:ext cx="3451108" cy="3237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D5AD4187-6A40-C038-A705-00A0DF768FD7}"/>
              </a:ext>
            </a:extLst>
          </p:cNvPr>
          <p:cNvSpPr/>
          <p:nvPr/>
        </p:nvSpPr>
        <p:spPr>
          <a:xfrm>
            <a:off x="6277538" y="3165499"/>
            <a:ext cx="3759548" cy="2847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3B6C29C-96E5-CB2F-757F-D05BC10632DA}"/>
              </a:ext>
            </a:extLst>
          </p:cNvPr>
          <p:cNvSpPr txBox="1"/>
          <p:nvPr/>
        </p:nvSpPr>
        <p:spPr>
          <a:xfrm>
            <a:off x="3072621" y="2075679"/>
            <a:ext cx="7533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03499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F80F8FE-BA54-9256-0098-6BA1FD18C361}"/>
              </a:ext>
            </a:extLst>
          </p:cNvPr>
          <p:cNvSpPr txBox="1"/>
          <p:nvPr/>
        </p:nvSpPr>
        <p:spPr>
          <a:xfrm>
            <a:off x="1617656" y="865809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4b</a:t>
            </a:r>
          </a:p>
        </p:txBody>
      </p:sp>
      <p:grpSp>
        <p:nvGrpSpPr>
          <p:cNvPr id="76" name="Group 75">
            <a:extLst>
              <a:ext uri="{FF2B5EF4-FFF2-40B4-BE49-F238E27FC236}">
                <a16:creationId xmlns:a16="http://schemas.microsoft.com/office/drawing/2014/main" id="{D568D447-1119-AF61-F8E8-12F92ADA0FCC}"/>
              </a:ext>
            </a:extLst>
          </p:cNvPr>
          <p:cNvGrpSpPr/>
          <p:nvPr/>
        </p:nvGrpSpPr>
        <p:grpSpPr>
          <a:xfrm>
            <a:off x="7237865" y="2161245"/>
            <a:ext cx="3984924" cy="2275813"/>
            <a:chOff x="7450081" y="3039166"/>
            <a:chExt cx="2024259" cy="1730502"/>
          </a:xfrm>
        </p:grpSpPr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84B04F7F-D31A-6164-75CA-385739D6FB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41" r="22710"/>
            <a:stretch/>
          </p:blipFill>
          <p:spPr>
            <a:xfrm>
              <a:off x="7825556" y="3039166"/>
              <a:ext cx="1277303" cy="1730502"/>
            </a:xfrm>
            <a:prstGeom prst="rect">
              <a:avLst/>
            </a:prstGeom>
          </p:spPr>
        </p:pic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A2C153AE-5BC4-15B5-8189-DFF1741CE36E}"/>
                </a:ext>
              </a:extLst>
            </p:cNvPr>
            <p:cNvSpPr/>
            <p:nvPr/>
          </p:nvSpPr>
          <p:spPr>
            <a:xfrm>
              <a:off x="7735301" y="3674495"/>
              <a:ext cx="1397159" cy="21482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3B1B197-B379-D73F-95CF-46D62223277C}"/>
                </a:ext>
              </a:extLst>
            </p:cNvPr>
            <p:cNvSpPr txBox="1"/>
            <p:nvPr/>
          </p:nvSpPr>
          <p:spPr>
            <a:xfrm>
              <a:off x="9172075" y="3658508"/>
              <a:ext cx="302265" cy="2574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CDCA4F60-6B45-03B2-E144-FA6ABD2FC2F6}"/>
                </a:ext>
              </a:extLst>
            </p:cNvPr>
            <p:cNvCxnSpPr/>
            <p:nvPr/>
          </p:nvCxnSpPr>
          <p:spPr>
            <a:xfrm>
              <a:off x="7742215" y="3735451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2D830110-CEA0-24DA-1BE4-072C87473A32}"/>
                </a:ext>
              </a:extLst>
            </p:cNvPr>
            <p:cNvSpPr txBox="1"/>
            <p:nvPr/>
          </p:nvSpPr>
          <p:spPr>
            <a:xfrm>
              <a:off x="7450081" y="3581562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75</a:t>
              </a:r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1CADA3C8-C929-FAC2-AF50-004A4959EBA2}"/>
                </a:ext>
              </a:extLst>
            </p:cNvPr>
            <p:cNvCxnSpPr/>
            <p:nvPr/>
          </p:nvCxnSpPr>
          <p:spPr>
            <a:xfrm>
              <a:off x="7742215" y="3942776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31D5B245-9B9F-352D-DA6F-FC39D423DD9F}"/>
                </a:ext>
              </a:extLst>
            </p:cNvPr>
            <p:cNvSpPr txBox="1"/>
            <p:nvPr/>
          </p:nvSpPr>
          <p:spPr>
            <a:xfrm>
              <a:off x="7450081" y="3788887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0</a:t>
              </a:r>
            </a:p>
          </p:txBody>
        </p:sp>
      </p:grpSp>
      <p:grpSp>
        <p:nvGrpSpPr>
          <p:cNvPr id="78" name="Group 77">
            <a:extLst>
              <a:ext uri="{FF2B5EF4-FFF2-40B4-BE49-F238E27FC236}">
                <a16:creationId xmlns:a16="http://schemas.microsoft.com/office/drawing/2014/main" id="{013798E5-5708-AB86-C2F3-3023F2D19EC3}"/>
              </a:ext>
            </a:extLst>
          </p:cNvPr>
          <p:cNvGrpSpPr/>
          <p:nvPr/>
        </p:nvGrpSpPr>
        <p:grpSpPr>
          <a:xfrm>
            <a:off x="7823105" y="4513303"/>
            <a:ext cx="3541658" cy="2177059"/>
            <a:chOff x="9172909" y="2923636"/>
            <a:chExt cx="2283077" cy="1730502"/>
          </a:xfrm>
        </p:grpSpPr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9DA78BD5-546B-3F93-74FB-1BF6A61E38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09" r="26847"/>
            <a:stretch/>
          </p:blipFill>
          <p:spPr>
            <a:xfrm flipH="1">
              <a:off x="9557756" y="2923636"/>
              <a:ext cx="1363028" cy="1730502"/>
            </a:xfrm>
            <a:prstGeom prst="rect">
              <a:avLst/>
            </a:prstGeom>
          </p:spPr>
        </p:pic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44D130B5-0BC3-EAF4-BB88-D1B7EA7BF315}"/>
                </a:ext>
              </a:extLst>
            </p:cNvPr>
            <p:cNvSpPr/>
            <p:nvPr/>
          </p:nvSpPr>
          <p:spPr>
            <a:xfrm>
              <a:off x="9414496" y="3574058"/>
              <a:ext cx="1506287" cy="21482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CEF0BF0A-4514-4AE8-87DA-836607803289}"/>
                </a:ext>
              </a:extLst>
            </p:cNvPr>
            <p:cNvSpPr txBox="1"/>
            <p:nvPr/>
          </p:nvSpPr>
          <p:spPr>
            <a:xfrm>
              <a:off x="10992838" y="3566056"/>
              <a:ext cx="463148" cy="269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NX5</a:t>
              </a:r>
            </a:p>
          </p:txBody>
        </p: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81D66CB7-D140-5FEB-D68F-3BB573C891F5}"/>
                </a:ext>
              </a:extLst>
            </p:cNvPr>
            <p:cNvCxnSpPr/>
            <p:nvPr/>
          </p:nvCxnSpPr>
          <p:spPr>
            <a:xfrm>
              <a:off x="9465043" y="3654049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7338FDB2-4B67-8468-CC6E-3E2B051B1D95}"/>
                </a:ext>
              </a:extLst>
            </p:cNvPr>
            <p:cNvSpPr txBox="1"/>
            <p:nvPr/>
          </p:nvSpPr>
          <p:spPr>
            <a:xfrm>
              <a:off x="9172909" y="350016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0</a:t>
              </a:r>
            </a:p>
          </p:txBody>
        </p: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5126DD76-F57E-ACD3-1C6F-7C096128AD08}"/>
                </a:ext>
              </a:extLst>
            </p:cNvPr>
            <p:cNvCxnSpPr/>
            <p:nvPr/>
          </p:nvCxnSpPr>
          <p:spPr>
            <a:xfrm>
              <a:off x="9465043" y="3947099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DAC1E77-0DBB-AC28-D541-A52A08B64B74}"/>
                </a:ext>
              </a:extLst>
            </p:cNvPr>
            <p:cNvSpPr txBox="1"/>
            <p:nvPr/>
          </p:nvSpPr>
          <p:spPr>
            <a:xfrm>
              <a:off x="9172909" y="379321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37</a:t>
              </a:r>
            </a:p>
          </p:txBody>
        </p:sp>
      </p:grpSp>
      <p:grpSp>
        <p:nvGrpSpPr>
          <p:cNvPr id="74" name="Group 73">
            <a:extLst>
              <a:ext uri="{FF2B5EF4-FFF2-40B4-BE49-F238E27FC236}">
                <a16:creationId xmlns:a16="http://schemas.microsoft.com/office/drawing/2014/main" id="{E6829099-BE19-776F-659B-DA2E6BCB0C1B}"/>
              </a:ext>
            </a:extLst>
          </p:cNvPr>
          <p:cNvGrpSpPr/>
          <p:nvPr/>
        </p:nvGrpSpPr>
        <p:grpSpPr>
          <a:xfrm>
            <a:off x="524628" y="2178241"/>
            <a:ext cx="3498898" cy="2275395"/>
            <a:chOff x="516513" y="2243613"/>
            <a:chExt cx="3122105" cy="1915668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4EF8F4D-D067-2C03-4FA8-EAEF6A0CD8B0}"/>
                </a:ext>
              </a:extLst>
            </p:cNvPr>
            <p:cNvSpPr txBox="1"/>
            <p:nvPr/>
          </p:nvSpPr>
          <p:spPr>
            <a:xfrm>
              <a:off x="3107662" y="2842809"/>
              <a:ext cx="530956" cy="2850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7E1E5142-419B-0BF5-4B63-936E09487C0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269" y="2243613"/>
              <a:ext cx="2564892" cy="1915668"/>
            </a:xfrm>
            <a:prstGeom prst="rect">
              <a:avLst/>
            </a:prstGeom>
          </p:spPr>
        </p:pic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B413263B-AC58-5572-F9C9-7168E5928C20}"/>
                </a:ext>
              </a:extLst>
            </p:cNvPr>
            <p:cNvSpPr/>
            <p:nvPr/>
          </p:nvSpPr>
          <p:spPr>
            <a:xfrm>
              <a:off x="1009697" y="2851722"/>
              <a:ext cx="1668036" cy="21482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FFD3D839-429A-D63A-3FE9-6E982A9541A1}"/>
                </a:ext>
              </a:extLst>
            </p:cNvPr>
            <p:cNvCxnSpPr/>
            <p:nvPr/>
          </p:nvCxnSpPr>
          <p:spPr>
            <a:xfrm>
              <a:off x="808647" y="2868751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778F1E38-3C54-D10E-5038-91564F6E0C4B}"/>
                </a:ext>
              </a:extLst>
            </p:cNvPr>
            <p:cNvSpPr txBox="1"/>
            <p:nvPr/>
          </p:nvSpPr>
          <p:spPr>
            <a:xfrm>
              <a:off x="516513" y="2714862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75</a:t>
              </a:r>
            </a:p>
          </p:txBody>
        </p: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0A117830-23B5-05F9-46DA-B951DA483209}"/>
                </a:ext>
              </a:extLst>
            </p:cNvPr>
            <p:cNvCxnSpPr/>
            <p:nvPr/>
          </p:nvCxnSpPr>
          <p:spPr>
            <a:xfrm>
              <a:off x="808647" y="3066551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EA0E2717-986A-7D53-1140-3F97C908BAD9}"/>
                </a:ext>
              </a:extLst>
            </p:cNvPr>
            <p:cNvSpPr txBox="1"/>
            <p:nvPr/>
          </p:nvSpPr>
          <p:spPr>
            <a:xfrm>
              <a:off x="516513" y="2912662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0</a:t>
              </a:r>
            </a:p>
          </p:txBody>
        </p: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29358653-AB49-15E4-2D97-300A12FE9C72}"/>
              </a:ext>
            </a:extLst>
          </p:cNvPr>
          <p:cNvGrpSpPr/>
          <p:nvPr/>
        </p:nvGrpSpPr>
        <p:grpSpPr>
          <a:xfrm>
            <a:off x="580988" y="4745379"/>
            <a:ext cx="3345172" cy="2033759"/>
            <a:chOff x="679666" y="4554228"/>
            <a:chExt cx="3057791" cy="1911096"/>
          </a:xfrm>
        </p:grpSpPr>
        <p:pic>
          <p:nvPicPr>
            <p:cNvPr id="58" name="Picture 57">
              <a:extLst>
                <a:ext uri="{FF2B5EF4-FFF2-40B4-BE49-F238E27FC236}">
                  <a16:creationId xmlns:a16="http://schemas.microsoft.com/office/drawing/2014/main" id="{A57EB541-7208-D2DB-507B-C3E7B075ED7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4256" y="4554228"/>
              <a:ext cx="2564892" cy="1911096"/>
            </a:xfrm>
            <a:prstGeom prst="rect">
              <a:avLst/>
            </a:prstGeom>
          </p:spPr>
        </p:pic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CE8E6BA-EFEB-FD0A-E06E-7B827613C459}"/>
                </a:ext>
              </a:extLst>
            </p:cNvPr>
            <p:cNvSpPr txBox="1"/>
            <p:nvPr/>
          </p:nvSpPr>
          <p:spPr>
            <a:xfrm>
              <a:off x="3018991" y="5165757"/>
              <a:ext cx="7184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NX5</a:t>
              </a: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DA417F82-2B96-1BD1-6D1A-6CFCB0B936F5}"/>
                </a:ext>
              </a:extLst>
            </p:cNvPr>
            <p:cNvSpPr/>
            <p:nvPr/>
          </p:nvSpPr>
          <p:spPr>
            <a:xfrm>
              <a:off x="1217606" y="5227620"/>
              <a:ext cx="1668036" cy="21482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A29C97DE-DCB8-F0E3-6C8F-9477666EEB8C}"/>
                </a:ext>
              </a:extLst>
            </p:cNvPr>
            <p:cNvCxnSpPr/>
            <p:nvPr/>
          </p:nvCxnSpPr>
          <p:spPr>
            <a:xfrm>
              <a:off x="971800" y="5308128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CDC0D473-39F2-033C-A299-7EA33048687E}"/>
                </a:ext>
              </a:extLst>
            </p:cNvPr>
            <p:cNvSpPr txBox="1"/>
            <p:nvPr/>
          </p:nvSpPr>
          <p:spPr>
            <a:xfrm>
              <a:off x="679666" y="5154239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0</a:t>
              </a:r>
            </a:p>
          </p:txBody>
        </p: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63EAB58D-A6FF-0A04-A733-D6D9BEC97079}"/>
                </a:ext>
              </a:extLst>
            </p:cNvPr>
            <p:cNvCxnSpPr/>
            <p:nvPr/>
          </p:nvCxnSpPr>
          <p:spPr>
            <a:xfrm>
              <a:off x="971800" y="5601178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F081BE0A-3BFD-1135-4043-AD2CDEC89E8E}"/>
                </a:ext>
              </a:extLst>
            </p:cNvPr>
            <p:cNvSpPr txBox="1"/>
            <p:nvPr/>
          </p:nvSpPr>
          <p:spPr>
            <a:xfrm>
              <a:off x="679666" y="5447289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37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1243B86-7BA5-13C6-857C-7531DDC34D41}"/>
              </a:ext>
            </a:extLst>
          </p:cNvPr>
          <p:cNvSpPr txBox="1"/>
          <p:nvPr/>
        </p:nvSpPr>
        <p:spPr>
          <a:xfrm>
            <a:off x="8421039" y="794024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4c </a:t>
            </a:r>
          </a:p>
        </p:txBody>
      </p:sp>
    </p:spTree>
    <p:extLst>
      <p:ext uri="{BB962C8B-B14F-4D97-AF65-F5344CB8AC3E}">
        <p14:creationId xmlns:p14="http://schemas.microsoft.com/office/powerpoint/2010/main" val="2245057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4FB1130-4BD7-197C-50FF-EFEDCEF7E15B}"/>
              </a:ext>
            </a:extLst>
          </p:cNvPr>
          <p:cNvSpPr txBox="1"/>
          <p:nvPr/>
        </p:nvSpPr>
        <p:spPr>
          <a:xfrm>
            <a:off x="862553" y="56756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4g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9804662-7D1E-7D5A-E801-68377F68A242}"/>
              </a:ext>
            </a:extLst>
          </p:cNvPr>
          <p:cNvSpPr txBox="1"/>
          <p:nvPr/>
        </p:nvSpPr>
        <p:spPr>
          <a:xfrm>
            <a:off x="2854791" y="2228761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B7A26A9E-5C6C-B7AB-79AB-5F7DDF55990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01"/>
          <a:stretch/>
        </p:blipFill>
        <p:spPr>
          <a:xfrm>
            <a:off x="1693539" y="2704257"/>
            <a:ext cx="2792582" cy="1962912"/>
          </a:xfrm>
          <a:prstGeom prst="rect">
            <a:avLst/>
          </a:prstGeom>
        </p:spPr>
      </p:pic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862CC5D7-F709-A030-5224-8CD076A8D853}"/>
              </a:ext>
            </a:extLst>
          </p:cNvPr>
          <p:cNvCxnSpPr/>
          <p:nvPr/>
        </p:nvCxnSpPr>
        <p:spPr>
          <a:xfrm>
            <a:off x="1441957" y="3725514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8C4F6B5B-3885-5D15-1252-92BAC22AC2BF}"/>
              </a:ext>
            </a:extLst>
          </p:cNvPr>
          <p:cNvSpPr txBox="1"/>
          <p:nvPr/>
        </p:nvSpPr>
        <p:spPr>
          <a:xfrm>
            <a:off x="1149823" y="357162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E2FC4F96-7EE9-1BA5-0075-1A5587E5E9C7}"/>
              </a:ext>
            </a:extLst>
          </p:cNvPr>
          <p:cNvCxnSpPr/>
          <p:nvPr/>
        </p:nvCxnSpPr>
        <p:spPr>
          <a:xfrm>
            <a:off x="1435213" y="3390436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145C2B24-C006-2C29-E2D6-135B319FA783}"/>
              </a:ext>
            </a:extLst>
          </p:cNvPr>
          <p:cNvSpPr txBox="1"/>
          <p:nvPr/>
        </p:nvSpPr>
        <p:spPr>
          <a:xfrm>
            <a:off x="1143079" y="3236547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5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EF327391-C70C-F24A-269B-A0E706FEFFE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3262" y="2203204"/>
            <a:ext cx="3599688" cy="2682240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898F04F0-B723-B43C-1C3D-C86C36806B82}"/>
              </a:ext>
            </a:extLst>
          </p:cNvPr>
          <p:cNvSpPr txBox="1"/>
          <p:nvPr/>
        </p:nvSpPr>
        <p:spPr>
          <a:xfrm>
            <a:off x="8271280" y="2203204"/>
            <a:ext cx="9236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564514CB-738C-9D34-ED7F-77BC6BE76C9C}"/>
              </a:ext>
            </a:extLst>
          </p:cNvPr>
          <p:cNvCxnSpPr/>
          <p:nvPr/>
        </p:nvCxnSpPr>
        <p:spPr>
          <a:xfrm>
            <a:off x="7041692" y="3404279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C743CC06-98C7-7B39-1922-A5CE367397C9}"/>
              </a:ext>
            </a:extLst>
          </p:cNvPr>
          <p:cNvSpPr txBox="1"/>
          <p:nvPr/>
        </p:nvSpPr>
        <p:spPr>
          <a:xfrm>
            <a:off x="6749558" y="325039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7F5572A2-1AAF-2EC7-0299-FE4CEC2069F5}"/>
              </a:ext>
            </a:extLst>
          </p:cNvPr>
          <p:cNvCxnSpPr/>
          <p:nvPr/>
        </p:nvCxnSpPr>
        <p:spPr>
          <a:xfrm>
            <a:off x="7041692" y="3697329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21E0484E-9A20-5780-65AB-81353557BF93}"/>
              </a:ext>
            </a:extLst>
          </p:cNvPr>
          <p:cNvSpPr txBox="1"/>
          <p:nvPr/>
        </p:nvSpPr>
        <p:spPr>
          <a:xfrm>
            <a:off x="6749558" y="354344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D998A98F-9862-BDF7-8F27-E4B121943062}"/>
              </a:ext>
            </a:extLst>
          </p:cNvPr>
          <p:cNvSpPr/>
          <p:nvPr/>
        </p:nvSpPr>
        <p:spPr>
          <a:xfrm>
            <a:off x="1573581" y="3371620"/>
            <a:ext cx="3096261" cy="2810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46E8ACEC-E9C9-DAAB-7EE5-8178660EBA2B}"/>
              </a:ext>
            </a:extLst>
          </p:cNvPr>
          <p:cNvSpPr/>
          <p:nvPr/>
        </p:nvSpPr>
        <p:spPr>
          <a:xfrm>
            <a:off x="7395928" y="3425364"/>
            <a:ext cx="3096261" cy="2810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</p:spTree>
    <p:extLst>
      <p:ext uri="{BB962C8B-B14F-4D97-AF65-F5344CB8AC3E}">
        <p14:creationId xmlns:p14="http://schemas.microsoft.com/office/powerpoint/2010/main" val="31506991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2AC8BD95-F484-5399-32A9-F55840E42BAB}"/>
              </a:ext>
            </a:extLst>
          </p:cNvPr>
          <p:cNvSpPr txBox="1"/>
          <p:nvPr/>
        </p:nvSpPr>
        <p:spPr>
          <a:xfrm>
            <a:off x="1843820" y="679753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4h</a:t>
            </a: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B40BCFCB-90FF-64A0-0A34-7DBB8875851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10" r="7578" b="20682"/>
          <a:stretch/>
        </p:blipFill>
        <p:spPr>
          <a:xfrm>
            <a:off x="773179" y="1345113"/>
            <a:ext cx="2980944" cy="2127504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45574608-F059-E80C-8721-E23AFF97F02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48" t="13864" r="9609" b="6704"/>
          <a:stretch/>
        </p:blipFill>
        <p:spPr>
          <a:xfrm>
            <a:off x="700027" y="3802118"/>
            <a:ext cx="2935224" cy="2130552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842266F4-E280-3B74-C198-9A2D4F0B1EBC}"/>
              </a:ext>
            </a:extLst>
          </p:cNvPr>
          <p:cNvSpPr txBox="1"/>
          <p:nvPr/>
        </p:nvSpPr>
        <p:spPr>
          <a:xfrm>
            <a:off x="4009156" y="2223638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37E5371-1F19-8EFC-4E76-A9531CB2B5C4}"/>
              </a:ext>
            </a:extLst>
          </p:cNvPr>
          <p:cNvSpPr txBox="1"/>
          <p:nvPr/>
        </p:nvSpPr>
        <p:spPr>
          <a:xfrm>
            <a:off x="3918918" y="4540793"/>
            <a:ext cx="7184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NX5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ACF3EDFD-8469-C5E0-AABC-C1E1FABEAEE2}"/>
              </a:ext>
            </a:extLst>
          </p:cNvPr>
          <p:cNvSpPr/>
          <p:nvPr/>
        </p:nvSpPr>
        <p:spPr>
          <a:xfrm>
            <a:off x="595615" y="2239641"/>
            <a:ext cx="3424870" cy="2148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5FAE948F-E166-34C6-3859-69C6F95925AF}"/>
              </a:ext>
            </a:extLst>
          </p:cNvPr>
          <p:cNvSpPr/>
          <p:nvPr/>
        </p:nvSpPr>
        <p:spPr>
          <a:xfrm>
            <a:off x="494048" y="4540793"/>
            <a:ext cx="3424870" cy="2148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7D5FBFC8-C611-C0FD-BE5D-1347C8799602}"/>
              </a:ext>
            </a:extLst>
          </p:cNvPr>
          <p:cNvCxnSpPr/>
          <p:nvPr/>
        </p:nvCxnSpPr>
        <p:spPr>
          <a:xfrm>
            <a:off x="824778" y="4596239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F01CF7FA-B263-A02E-E0DA-A3673742E194}"/>
              </a:ext>
            </a:extLst>
          </p:cNvPr>
          <p:cNvSpPr txBox="1"/>
          <p:nvPr/>
        </p:nvSpPr>
        <p:spPr>
          <a:xfrm>
            <a:off x="532644" y="444235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051B7547-E8EF-F8ED-7FE0-49221FA807EC}"/>
              </a:ext>
            </a:extLst>
          </p:cNvPr>
          <p:cNvCxnSpPr/>
          <p:nvPr/>
        </p:nvCxnSpPr>
        <p:spPr>
          <a:xfrm>
            <a:off x="824778" y="4889289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623F957E-AF57-62CE-E4EF-214A09F2A5BC}"/>
              </a:ext>
            </a:extLst>
          </p:cNvPr>
          <p:cNvSpPr txBox="1"/>
          <p:nvPr/>
        </p:nvSpPr>
        <p:spPr>
          <a:xfrm>
            <a:off x="532644" y="473540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AFACAACB-B15D-B3C1-6380-4A67CFAD4994}"/>
              </a:ext>
            </a:extLst>
          </p:cNvPr>
          <p:cNvCxnSpPr/>
          <p:nvPr/>
        </p:nvCxnSpPr>
        <p:spPr>
          <a:xfrm>
            <a:off x="761240" y="2211353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B6E470B5-D3CB-50AB-ACC7-F4C86F0C81B6}"/>
              </a:ext>
            </a:extLst>
          </p:cNvPr>
          <p:cNvSpPr txBox="1"/>
          <p:nvPr/>
        </p:nvSpPr>
        <p:spPr>
          <a:xfrm>
            <a:off x="469106" y="2057464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5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986A7370-29ED-45BB-1799-AFB815FB0E11}"/>
              </a:ext>
            </a:extLst>
          </p:cNvPr>
          <p:cNvCxnSpPr/>
          <p:nvPr/>
        </p:nvCxnSpPr>
        <p:spPr>
          <a:xfrm>
            <a:off x="761240" y="2504403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5874F0DE-8FE5-3F83-BA47-36DCD68DD190}"/>
              </a:ext>
            </a:extLst>
          </p:cNvPr>
          <p:cNvSpPr txBox="1"/>
          <p:nvPr/>
        </p:nvSpPr>
        <p:spPr>
          <a:xfrm>
            <a:off x="469106" y="2350514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</a:t>
            </a:r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4F0C36ED-8CC3-AE2F-0B1E-98A79445908C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41" t="18977" r="9611" b="6704"/>
          <a:stretch/>
        </p:blipFill>
        <p:spPr>
          <a:xfrm>
            <a:off x="7533119" y="1226942"/>
            <a:ext cx="2953512" cy="1993392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B911863D-0F72-EF04-4FB8-5A84E9440E8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08" t="15568" r="8595" b="7046"/>
          <a:stretch/>
        </p:blipFill>
        <p:spPr>
          <a:xfrm>
            <a:off x="7478255" y="3782247"/>
            <a:ext cx="3063240" cy="2075688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62AF23E3-50D3-84C1-1550-90E715D47B8D}"/>
              </a:ext>
            </a:extLst>
          </p:cNvPr>
          <p:cNvSpPr txBox="1"/>
          <p:nvPr/>
        </p:nvSpPr>
        <p:spPr>
          <a:xfrm>
            <a:off x="10735524" y="1916084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D9C6996-8CFD-A5CD-500A-DAAB685EF47D}"/>
              </a:ext>
            </a:extLst>
          </p:cNvPr>
          <p:cNvSpPr txBox="1"/>
          <p:nvPr/>
        </p:nvSpPr>
        <p:spPr>
          <a:xfrm>
            <a:off x="10646689" y="4503821"/>
            <a:ext cx="7184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NX5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1A1FD151-D02E-07B1-C8E9-63A02716AFC2}"/>
              </a:ext>
            </a:extLst>
          </p:cNvPr>
          <p:cNvSpPr/>
          <p:nvPr/>
        </p:nvSpPr>
        <p:spPr>
          <a:xfrm>
            <a:off x="7211042" y="1932087"/>
            <a:ext cx="3424870" cy="2148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7AD98FE4-6909-C1AA-2727-9D24E03BA9F4}"/>
              </a:ext>
            </a:extLst>
          </p:cNvPr>
          <p:cNvSpPr/>
          <p:nvPr/>
        </p:nvSpPr>
        <p:spPr>
          <a:xfrm>
            <a:off x="7180836" y="4544542"/>
            <a:ext cx="3424870" cy="2148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0A4AB3FD-F9C7-64CC-E6ED-DFAFE85DD4D2}"/>
              </a:ext>
            </a:extLst>
          </p:cNvPr>
          <p:cNvCxnSpPr/>
          <p:nvPr/>
        </p:nvCxnSpPr>
        <p:spPr>
          <a:xfrm>
            <a:off x="7503176" y="4620210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3CD7F757-7393-EBDF-82B3-C669A42E2636}"/>
              </a:ext>
            </a:extLst>
          </p:cNvPr>
          <p:cNvSpPr txBox="1"/>
          <p:nvPr/>
        </p:nvSpPr>
        <p:spPr>
          <a:xfrm>
            <a:off x="7211042" y="4466321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292A7417-3E66-BF6A-5CBF-2AE36A981D29}"/>
              </a:ext>
            </a:extLst>
          </p:cNvPr>
          <p:cNvCxnSpPr/>
          <p:nvPr/>
        </p:nvCxnSpPr>
        <p:spPr>
          <a:xfrm>
            <a:off x="7503176" y="4913260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C6112FA8-8881-E305-1C00-196FF39B7197}"/>
              </a:ext>
            </a:extLst>
          </p:cNvPr>
          <p:cNvSpPr txBox="1"/>
          <p:nvPr/>
        </p:nvSpPr>
        <p:spPr>
          <a:xfrm>
            <a:off x="7211042" y="4759371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</a:t>
            </a: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CD0C5A32-48AF-EA7D-ABB4-68AE7FF3D238}"/>
              </a:ext>
            </a:extLst>
          </p:cNvPr>
          <p:cNvCxnSpPr/>
          <p:nvPr/>
        </p:nvCxnSpPr>
        <p:spPr>
          <a:xfrm>
            <a:off x="7543540" y="1961211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195F81DA-246D-C935-9B96-93CCADC63B05}"/>
              </a:ext>
            </a:extLst>
          </p:cNvPr>
          <p:cNvSpPr txBox="1"/>
          <p:nvPr/>
        </p:nvSpPr>
        <p:spPr>
          <a:xfrm>
            <a:off x="7251406" y="180732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5</a:t>
            </a: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850E2910-9E6F-FF28-0BA4-EDC839B570B1}"/>
              </a:ext>
            </a:extLst>
          </p:cNvPr>
          <p:cNvCxnSpPr/>
          <p:nvPr/>
        </p:nvCxnSpPr>
        <p:spPr>
          <a:xfrm>
            <a:off x="7543540" y="2206636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9ECE774D-D28F-FCEF-E4FB-201EA6FF6830}"/>
              </a:ext>
            </a:extLst>
          </p:cNvPr>
          <p:cNvSpPr txBox="1"/>
          <p:nvPr/>
        </p:nvSpPr>
        <p:spPr>
          <a:xfrm>
            <a:off x="7251406" y="2052747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12CFADF-4802-72FC-BB8E-5946873AC893}"/>
              </a:ext>
            </a:extLst>
          </p:cNvPr>
          <p:cNvSpPr txBox="1"/>
          <p:nvPr/>
        </p:nvSpPr>
        <p:spPr>
          <a:xfrm>
            <a:off x="8497719" y="495087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4i</a:t>
            </a:r>
          </a:p>
        </p:txBody>
      </p:sp>
    </p:spTree>
    <p:extLst>
      <p:ext uri="{BB962C8B-B14F-4D97-AF65-F5344CB8AC3E}">
        <p14:creationId xmlns:p14="http://schemas.microsoft.com/office/powerpoint/2010/main" val="21399572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FDF0824C-2A9F-D2F9-2638-E1CCB2EA88D0}"/>
              </a:ext>
            </a:extLst>
          </p:cNvPr>
          <p:cNvSpPr txBox="1"/>
          <p:nvPr/>
        </p:nvSpPr>
        <p:spPr>
          <a:xfrm>
            <a:off x="922385" y="878503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4j</a:t>
            </a: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E075167B-6DE3-B462-6C2E-11E1985396D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7" t="554" r="201" b="13089"/>
          <a:stretch/>
        </p:blipFill>
        <p:spPr>
          <a:xfrm flipV="1">
            <a:off x="5146244" y="4219838"/>
            <a:ext cx="2439249" cy="184387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A9CFAEF7-DD9E-44C8-7341-7CD454F138F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40" t="55728" r="48384" b="18"/>
          <a:stretch/>
        </p:blipFill>
        <p:spPr>
          <a:xfrm flipV="1">
            <a:off x="8101743" y="3957579"/>
            <a:ext cx="3180875" cy="210613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95A23641-3777-1AE1-81A6-51658ECBA90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66000"/>
                    </a14:imgEffect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6" t="2243" r="571" b="524"/>
          <a:stretch/>
        </p:blipFill>
        <p:spPr>
          <a:xfrm flipV="1">
            <a:off x="4258331" y="723480"/>
            <a:ext cx="2257262" cy="184387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3684B8A1-9CA3-12E1-AAC6-DC3A7D0F86C8}"/>
              </a:ext>
            </a:extLst>
          </p:cNvPr>
          <p:cNvSpPr txBox="1"/>
          <p:nvPr/>
        </p:nvSpPr>
        <p:spPr>
          <a:xfrm>
            <a:off x="5146244" y="367058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064226B1-D699-D08F-EE8D-87E808A59A2E}"/>
              </a:ext>
            </a:extLst>
          </p:cNvPr>
          <p:cNvCxnSpPr/>
          <p:nvPr/>
        </p:nvCxnSpPr>
        <p:spPr>
          <a:xfrm>
            <a:off x="4360982" y="1489681"/>
            <a:ext cx="275471" cy="1258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18EAFE54-92A5-7555-C462-F40069BE0EE8}"/>
              </a:ext>
            </a:extLst>
          </p:cNvPr>
          <p:cNvSpPr txBox="1"/>
          <p:nvPr/>
        </p:nvSpPr>
        <p:spPr>
          <a:xfrm>
            <a:off x="4033592" y="1306895"/>
            <a:ext cx="411749" cy="3655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5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92D611DE-909A-76FE-0887-FC81534A6A0B}"/>
              </a:ext>
            </a:extLst>
          </p:cNvPr>
          <p:cNvCxnSpPr/>
          <p:nvPr/>
        </p:nvCxnSpPr>
        <p:spPr>
          <a:xfrm>
            <a:off x="4360982" y="1724625"/>
            <a:ext cx="275471" cy="1258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518E6F75-CC00-31C1-AE76-8FCF65E83218}"/>
              </a:ext>
            </a:extLst>
          </p:cNvPr>
          <p:cNvSpPr txBox="1"/>
          <p:nvPr/>
        </p:nvSpPr>
        <p:spPr>
          <a:xfrm>
            <a:off x="4033592" y="1541838"/>
            <a:ext cx="411749" cy="3655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B3A665DD-1E13-8CB6-11D3-B991310EC16E}"/>
              </a:ext>
            </a:extLst>
          </p:cNvPr>
          <p:cNvSpPr/>
          <p:nvPr/>
        </p:nvSpPr>
        <p:spPr>
          <a:xfrm>
            <a:off x="4547992" y="1474919"/>
            <a:ext cx="2176645" cy="2847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67" name="Group 66">
            <a:extLst>
              <a:ext uri="{FF2B5EF4-FFF2-40B4-BE49-F238E27FC236}">
                <a16:creationId xmlns:a16="http://schemas.microsoft.com/office/drawing/2014/main" id="{7EC68D6A-E9AE-06C7-2D46-C520CC6D69A1}"/>
              </a:ext>
            </a:extLst>
          </p:cNvPr>
          <p:cNvGrpSpPr/>
          <p:nvPr/>
        </p:nvGrpSpPr>
        <p:grpSpPr>
          <a:xfrm>
            <a:off x="8319957" y="997701"/>
            <a:ext cx="2860395" cy="1488044"/>
            <a:chOff x="8319957" y="997701"/>
            <a:chExt cx="2860395" cy="1488044"/>
          </a:xfrm>
        </p:grpSpPr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F883A66D-8A43-50B7-4C20-A46AC406DB13}"/>
                </a:ext>
              </a:extLst>
            </p:cNvPr>
            <p:cNvSpPr txBox="1"/>
            <p:nvPr/>
          </p:nvSpPr>
          <p:spPr>
            <a:xfrm>
              <a:off x="10342383" y="997701"/>
              <a:ext cx="785990" cy="3602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NX5</a:t>
              </a:r>
            </a:p>
          </p:txBody>
        </p:sp>
        <p:pic>
          <p:nvPicPr>
            <p:cNvPr id="66" name="Picture 65">
              <a:extLst>
                <a:ext uri="{FF2B5EF4-FFF2-40B4-BE49-F238E27FC236}">
                  <a16:creationId xmlns:a16="http://schemas.microsoft.com/office/drawing/2014/main" id="{CD9B68BF-C65D-8717-1567-A46C00E30AB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93184" y="1357985"/>
              <a:ext cx="2487168" cy="1127760"/>
            </a:xfrm>
            <a:prstGeom prst="rect">
              <a:avLst/>
            </a:prstGeom>
          </p:spPr>
        </p:pic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D16B2070-1061-7F28-D3D3-68C278826C10}"/>
                </a:ext>
              </a:extLst>
            </p:cNvPr>
            <p:cNvCxnSpPr/>
            <p:nvPr/>
          </p:nvCxnSpPr>
          <p:spPr>
            <a:xfrm>
              <a:off x="8612091" y="1937456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FA4C39DB-8CC9-E9C5-2E3A-99C9202DEADF}"/>
                </a:ext>
              </a:extLst>
            </p:cNvPr>
            <p:cNvSpPr txBox="1"/>
            <p:nvPr/>
          </p:nvSpPr>
          <p:spPr>
            <a:xfrm>
              <a:off x="8319957" y="1783567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0</a:t>
              </a:r>
            </a:p>
          </p:txBody>
        </p: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BA8080B5-C5A5-8185-91CD-BC5A901B81F8}"/>
                </a:ext>
              </a:extLst>
            </p:cNvPr>
            <p:cNvCxnSpPr/>
            <p:nvPr/>
          </p:nvCxnSpPr>
          <p:spPr>
            <a:xfrm>
              <a:off x="8612091" y="2230506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12CACAD-DA13-631B-69C7-719E9EB317C8}"/>
                </a:ext>
              </a:extLst>
            </p:cNvPr>
            <p:cNvSpPr txBox="1"/>
            <p:nvPr/>
          </p:nvSpPr>
          <p:spPr>
            <a:xfrm>
              <a:off x="8319957" y="2076617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37</a:t>
              </a:r>
            </a:p>
          </p:txBody>
        </p:sp>
      </p:grpSp>
      <p:sp>
        <p:nvSpPr>
          <p:cNvPr id="58" name="Rectangle 57">
            <a:extLst>
              <a:ext uri="{FF2B5EF4-FFF2-40B4-BE49-F238E27FC236}">
                <a16:creationId xmlns:a16="http://schemas.microsoft.com/office/drawing/2014/main" id="{7B8CBD1B-3A7F-3C3F-F3BB-E0736DE4C8EB}"/>
              </a:ext>
            </a:extLst>
          </p:cNvPr>
          <p:cNvSpPr/>
          <p:nvPr/>
        </p:nvSpPr>
        <p:spPr>
          <a:xfrm>
            <a:off x="8930802" y="1893943"/>
            <a:ext cx="2351816" cy="2847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75" name="Group 74">
            <a:extLst>
              <a:ext uri="{FF2B5EF4-FFF2-40B4-BE49-F238E27FC236}">
                <a16:creationId xmlns:a16="http://schemas.microsoft.com/office/drawing/2014/main" id="{4A95ABBD-1184-9E8E-91B6-D39928C64C0C}"/>
              </a:ext>
            </a:extLst>
          </p:cNvPr>
          <p:cNvGrpSpPr/>
          <p:nvPr/>
        </p:nvGrpSpPr>
        <p:grpSpPr>
          <a:xfrm>
            <a:off x="483721" y="3564125"/>
            <a:ext cx="3065625" cy="2499586"/>
            <a:chOff x="662517" y="3564128"/>
            <a:chExt cx="3065625" cy="2499586"/>
          </a:xfrm>
        </p:grpSpPr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47AD0D73-B107-4D03-F8B5-1E21300AA8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1" t="-87" r="181" b="-675"/>
            <a:stretch/>
          </p:blipFill>
          <p:spPr>
            <a:xfrm>
              <a:off x="1101181" y="3957581"/>
              <a:ext cx="2626961" cy="210613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5D80398-7D04-E60D-74F8-86004F99BC14}"/>
                </a:ext>
              </a:extLst>
            </p:cNvPr>
            <p:cNvSpPr txBox="1"/>
            <p:nvPr/>
          </p:nvSpPr>
          <p:spPr>
            <a:xfrm>
              <a:off x="1949525" y="3564128"/>
              <a:ext cx="92365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9D459A5E-5378-CADE-BDC1-2D930B6D9764}"/>
                </a:ext>
              </a:extLst>
            </p:cNvPr>
            <p:cNvCxnSpPr/>
            <p:nvPr/>
          </p:nvCxnSpPr>
          <p:spPr>
            <a:xfrm>
              <a:off x="954651" y="4944537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7F816536-C21C-A720-6C01-27B386A71061}"/>
                </a:ext>
              </a:extLst>
            </p:cNvPr>
            <p:cNvSpPr txBox="1"/>
            <p:nvPr/>
          </p:nvSpPr>
          <p:spPr>
            <a:xfrm>
              <a:off x="662517" y="4790648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0</a:t>
              </a:r>
            </a:p>
          </p:txBody>
        </p: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AF80256B-5B64-6D7D-49CF-70C70A43B971}"/>
                </a:ext>
              </a:extLst>
            </p:cNvPr>
            <p:cNvCxnSpPr/>
            <p:nvPr/>
          </p:nvCxnSpPr>
          <p:spPr>
            <a:xfrm>
              <a:off x="954651" y="5237587"/>
              <a:ext cx="245806" cy="105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4035EBF5-733F-6040-26AF-A1F2A750718B}"/>
                </a:ext>
              </a:extLst>
            </p:cNvPr>
            <p:cNvSpPr txBox="1"/>
            <p:nvPr/>
          </p:nvSpPr>
          <p:spPr>
            <a:xfrm>
              <a:off x="662517" y="5083698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37</a:t>
              </a:r>
            </a:p>
          </p:txBody>
        </p:sp>
      </p:grpSp>
      <p:sp>
        <p:nvSpPr>
          <p:cNvPr id="76" name="Rectangle 75">
            <a:extLst>
              <a:ext uri="{FF2B5EF4-FFF2-40B4-BE49-F238E27FC236}">
                <a16:creationId xmlns:a16="http://schemas.microsoft.com/office/drawing/2014/main" id="{1647DA07-1E0D-F0F0-C261-B26598C852D5}"/>
              </a:ext>
            </a:extLst>
          </p:cNvPr>
          <p:cNvSpPr/>
          <p:nvPr/>
        </p:nvSpPr>
        <p:spPr>
          <a:xfrm>
            <a:off x="1080114" y="4868265"/>
            <a:ext cx="2351816" cy="2847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9CB33EC1-4E1E-2A6D-4014-1C5E99DFC375}"/>
              </a:ext>
            </a:extLst>
          </p:cNvPr>
          <p:cNvSpPr txBox="1"/>
          <p:nvPr/>
        </p:nvSpPr>
        <p:spPr>
          <a:xfrm>
            <a:off x="5830226" y="3788301"/>
            <a:ext cx="9092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/>
              <a:t>Calnexin</a:t>
            </a:r>
            <a:endParaRPr lang="en-US" sz="1600" b="1" dirty="0"/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B6222FFD-17B8-AB56-39C6-6953B42935A5}"/>
              </a:ext>
            </a:extLst>
          </p:cNvPr>
          <p:cNvSpPr/>
          <p:nvPr/>
        </p:nvSpPr>
        <p:spPr>
          <a:xfrm>
            <a:off x="5228816" y="4594128"/>
            <a:ext cx="2176645" cy="2847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5AB318DD-5AC9-8938-A790-91698EA1AE85}"/>
              </a:ext>
            </a:extLst>
          </p:cNvPr>
          <p:cNvSpPr txBox="1"/>
          <p:nvPr/>
        </p:nvSpPr>
        <p:spPr>
          <a:xfrm>
            <a:off x="9395907" y="3577774"/>
            <a:ext cx="9124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E-Cad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CDD55041-BD74-5806-E189-C3841ADF7119}"/>
              </a:ext>
            </a:extLst>
          </p:cNvPr>
          <p:cNvSpPr/>
          <p:nvPr/>
        </p:nvSpPr>
        <p:spPr>
          <a:xfrm>
            <a:off x="8400770" y="5568426"/>
            <a:ext cx="2610130" cy="2847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20AF36E2-9431-9506-0B48-1AB58204B2E8}"/>
              </a:ext>
            </a:extLst>
          </p:cNvPr>
          <p:cNvCxnSpPr/>
          <p:nvPr/>
        </p:nvCxnSpPr>
        <p:spPr>
          <a:xfrm>
            <a:off x="11188158" y="5677839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B82E1441-8363-6C4F-C176-3953FF6A63C7}"/>
              </a:ext>
            </a:extLst>
          </p:cNvPr>
          <p:cNvSpPr txBox="1"/>
          <p:nvPr/>
        </p:nvSpPr>
        <p:spPr>
          <a:xfrm>
            <a:off x="11433964" y="5523950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0</a:t>
            </a: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B50794FC-1304-FEDB-BCC6-335870853769}"/>
              </a:ext>
            </a:extLst>
          </p:cNvPr>
          <p:cNvCxnSpPr/>
          <p:nvPr/>
        </p:nvCxnSpPr>
        <p:spPr>
          <a:xfrm>
            <a:off x="11178419" y="5834375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73714384-3918-08A7-6D71-DC9B80A45395}"/>
              </a:ext>
            </a:extLst>
          </p:cNvPr>
          <p:cNvSpPr txBox="1"/>
          <p:nvPr/>
        </p:nvSpPr>
        <p:spPr>
          <a:xfrm>
            <a:off x="11433964" y="5716153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0</a:t>
            </a:r>
          </a:p>
        </p:txBody>
      </p: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064226B1-D699-D08F-EE8D-87E808A59A2E}"/>
              </a:ext>
            </a:extLst>
          </p:cNvPr>
          <p:cNvCxnSpPr/>
          <p:nvPr/>
        </p:nvCxnSpPr>
        <p:spPr>
          <a:xfrm>
            <a:off x="5007615" y="4921090"/>
            <a:ext cx="275471" cy="1258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18EAFE54-92A5-7555-C462-F40069BE0EE8}"/>
              </a:ext>
            </a:extLst>
          </p:cNvPr>
          <p:cNvSpPr txBox="1"/>
          <p:nvPr/>
        </p:nvSpPr>
        <p:spPr>
          <a:xfrm>
            <a:off x="4680225" y="4738304"/>
            <a:ext cx="411749" cy="3655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5</a:t>
            </a: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92D611DE-909A-76FE-0887-FC81534A6A0B}"/>
              </a:ext>
            </a:extLst>
          </p:cNvPr>
          <p:cNvCxnSpPr/>
          <p:nvPr/>
        </p:nvCxnSpPr>
        <p:spPr>
          <a:xfrm>
            <a:off x="5007615" y="5156034"/>
            <a:ext cx="275471" cy="1258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518E6F75-CC00-31C1-AE76-8FCF65E83218}"/>
              </a:ext>
            </a:extLst>
          </p:cNvPr>
          <p:cNvSpPr txBox="1"/>
          <p:nvPr/>
        </p:nvSpPr>
        <p:spPr>
          <a:xfrm>
            <a:off x="4680225" y="4973247"/>
            <a:ext cx="411749" cy="3655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</a:t>
            </a:r>
          </a:p>
        </p:txBody>
      </p:sp>
    </p:spTree>
    <p:extLst>
      <p:ext uri="{BB962C8B-B14F-4D97-AF65-F5344CB8AC3E}">
        <p14:creationId xmlns:p14="http://schemas.microsoft.com/office/powerpoint/2010/main" val="17583978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0C32D84-F561-A4B0-44D9-F6091F53C898}"/>
              </a:ext>
            </a:extLst>
          </p:cNvPr>
          <p:cNvSpPr txBox="1"/>
          <p:nvPr/>
        </p:nvSpPr>
        <p:spPr>
          <a:xfrm>
            <a:off x="652553" y="59247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4q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64E34919-3415-A674-C86C-67C9B7E5DD2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9334" y="2815739"/>
            <a:ext cx="2596612" cy="1936587"/>
          </a:xfrm>
          <a:prstGeom prst="rect">
            <a:avLst/>
          </a:prstGeom>
        </p:spPr>
      </p:pic>
      <p:sp>
        <p:nvSpPr>
          <p:cNvPr id="35" name="Rectangle 34">
            <a:extLst>
              <a:ext uri="{FF2B5EF4-FFF2-40B4-BE49-F238E27FC236}">
                <a16:creationId xmlns:a16="http://schemas.microsoft.com/office/drawing/2014/main" id="{45FC4C59-BA1D-B26E-9514-26533E9A1CC7}"/>
              </a:ext>
            </a:extLst>
          </p:cNvPr>
          <p:cNvSpPr/>
          <p:nvPr/>
        </p:nvSpPr>
        <p:spPr>
          <a:xfrm>
            <a:off x="1705616" y="3428345"/>
            <a:ext cx="2511198" cy="28643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643A57CC-23BC-E0A1-8F15-0CA4B6EE6C7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6229" y="2729089"/>
            <a:ext cx="2643119" cy="1971387"/>
          </a:xfrm>
          <a:prstGeom prst="rect">
            <a:avLst/>
          </a:prstGeom>
        </p:spPr>
      </p:pic>
      <p:sp>
        <p:nvSpPr>
          <p:cNvPr id="37" name="Rectangle 36">
            <a:extLst>
              <a:ext uri="{FF2B5EF4-FFF2-40B4-BE49-F238E27FC236}">
                <a16:creationId xmlns:a16="http://schemas.microsoft.com/office/drawing/2014/main" id="{0BE51F07-F2CF-B71B-66E0-5AF2BCF37DAE}"/>
              </a:ext>
            </a:extLst>
          </p:cNvPr>
          <p:cNvSpPr/>
          <p:nvPr/>
        </p:nvSpPr>
        <p:spPr>
          <a:xfrm>
            <a:off x="6356173" y="3597908"/>
            <a:ext cx="2511198" cy="28643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5EBD54E-0B4B-CABC-8643-7CC32C492C04}"/>
              </a:ext>
            </a:extLst>
          </p:cNvPr>
          <p:cNvSpPr txBox="1"/>
          <p:nvPr/>
        </p:nvSpPr>
        <p:spPr>
          <a:xfrm>
            <a:off x="9179404" y="3644776"/>
            <a:ext cx="9236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897DF7E-2B8F-23AA-B623-47D4BE17706D}"/>
              </a:ext>
            </a:extLst>
          </p:cNvPr>
          <p:cNvSpPr txBox="1"/>
          <p:nvPr/>
        </p:nvSpPr>
        <p:spPr>
          <a:xfrm>
            <a:off x="4301827" y="3413944"/>
            <a:ext cx="7184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NX5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678A3B57-517E-AA41-1FC2-3DC6E0998799}"/>
              </a:ext>
            </a:extLst>
          </p:cNvPr>
          <p:cNvCxnSpPr/>
          <p:nvPr/>
        </p:nvCxnSpPr>
        <p:spPr>
          <a:xfrm>
            <a:off x="1458109" y="3508047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931AF7D1-204E-4C5A-A8A4-AEAD24B0FF4F}"/>
              </a:ext>
            </a:extLst>
          </p:cNvPr>
          <p:cNvSpPr txBox="1"/>
          <p:nvPr/>
        </p:nvSpPr>
        <p:spPr>
          <a:xfrm>
            <a:off x="1165975" y="335415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30E557FD-693C-E286-67EA-1BA3DE42E404}"/>
              </a:ext>
            </a:extLst>
          </p:cNvPr>
          <p:cNvCxnSpPr/>
          <p:nvPr/>
        </p:nvCxnSpPr>
        <p:spPr>
          <a:xfrm>
            <a:off x="1458109" y="3801097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83031C6F-E025-EFF9-E94A-1B585635258D}"/>
              </a:ext>
            </a:extLst>
          </p:cNvPr>
          <p:cNvSpPr txBox="1"/>
          <p:nvPr/>
        </p:nvSpPr>
        <p:spPr>
          <a:xfrm>
            <a:off x="1165975" y="364720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97BDB523-2FF4-A90F-329F-6949BB3B5360}"/>
              </a:ext>
            </a:extLst>
          </p:cNvPr>
          <p:cNvCxnSpPr/>
          <p:nvPr/>
        </p:nvCxnSpPr>
        <p:spPr>
          <a:xfrm>
            <a:off x="6413609" y="3644777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8079EBAB-B592-C0AA-D7D2-81EDF2261C8E}"/>
              </a:ext>
            </a:extLst>
          </p:cNvPr>
          <p:cNvSpPr txBox="1"/>
          <p:nvPr/>
        </p:nvSpPr>
        <p:spPr>
          <a:xfrm>
            <a:off x="6121475" y="349088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EDB7EFE9-6599-2BDC-29AB-45DC0F0F737A}"/>
              </a:ext>
            </a:extLst>
          </p:cNvPr>
          <p:cNvCxnSpPr/>
          <p:nvPr/>
        </p:nvCxnSpPr>
        <p:spPr>
          <a:xfrm>
            <a:off x="6413609" y="3937827"/>
            <a:ext cx="245806" cy="105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4CB4A082-CCDB-ED35-A70D-60D5E10A73E0}"/>
              </a:ext>
            </a:extLst>
          </p:cNvPr>
          <p:cNvSpPr txBox="1"/>
          <p:nvPr/>
        </p:nvSpPr>
        <p:spPr>
          <a:xfrm>
            <a:off x="6121475" y="378393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</a:t>
            </a:r>
          </a:p>
        </p:txBody>
      </p:sp>
    </p:spTree>
    <p:extLst>
      <p:ext uri="{BB962C8B-B14F-4D97-AF65-F5344CB8AC3E}">
        <p14:creationId xmlns:p14="http://schemas.microsoft.com/office/powerpoint/2010/main" val="15342925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6</TotalTime>
  <Words>117</Words>
  <Application>Microsoft Office PowerPoint</Application>
  <PresentationFormat>Widescreen</PresentationFormat>
  <Paragraphs>89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 Sacharidou</dc:creator>
  <cp:lastModifiedBy>Philip Shaul</cp:lastModifiedBy>
  <cp:revision>29</cp:revision>
  <dcterms:created xsi:type="dcterms:W3CDTF">2023-04-13T20:31:02Z</dcterms:created>
  <dcterms:modified xsi:type="dcterms:W3CDTF">2023-06-26T17:12:06Z</dcterms:modified>
</cp:coreProperties>
</file>